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064A1-1B1C-486F-BC06-B3EF166B73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F642D-F16D-4F87-838D-FA63AC9F86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FC12B0-5246-4293-839E-6123BD426A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DF6565-8AE8-4FE8-AD27-4D0871FDB9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AFF482-D545-4EE4-AB80-A31C862146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0B130-6353-4BC5-9FB5-1E0ED89FE3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97CCF5-2304-42C4-8F38-35422AAA07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FDC763-C931-489F-985B-A43BE82881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DADAC8-6283-4031-98A4-3B34332C29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C98C4-855B-4AD7-A85D-8AA911C7B4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41902-0EC6-44B1-9740-7B91D74754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8171F3-8994-42FD-8E84-ED2BA225FD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DA9705-ABD7-4C22-BA72-D0CCCDDE3B65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"/>
          <p:cNvGrpSpPr/>
          <p:nvPr/>
        </p:nvGrpSpPr>
        <p:grpSpPr>
          <a:xfrm>
            <a:off x="155520" y="334800"/>
            <a:ext cx="8016840" cy="6766200"/>
            <a:chOff x="155520" y="334800"/>
            <a:chExt cx="8016840" cy="6766200"/>
          </a:xfrm>
        </p:grpSpPr>
        <p:sp>
          <p:nvSpPr>
            <p:cNvPr id="42" name="Rectangle 3"/>
            <p:cNvSpPr/>
            <p:nvPr/>
          </p:nvSpPr>
          <p:spPr>
            <a:xfrm>
              <a:off x="2099880" y="334800"/>
              <a:ext cx="4230000" cy="1177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Assessed for eligibility  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Korean descent, right handed, and 18-65 years old volunteers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Schizophrenia (n=41)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- Meeting the DSM-IV-TR criteria for schizophrenia 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HC (n=27)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lvl="2" marL="539640" indent="-87120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- No personal or family history of psychiatric diseases in first-degree, biological relatives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3" name="Rectangle 4"/>
            <p:cNvSpPr/>
            <p:nvPr/>
          </p:nvSpPr>
          <p:spPr>
            <a:xfrm>
              <a:off x="5351400" y="1793880"/>
              <a:ext cx="2667240" cy="1349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Excluded 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Schizophrenia (n=4)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Not meeting inclusion criteria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	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- Major depression (n=1)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- Alcohol dependence (n=2)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- Brain ischemia (n=1)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HC (n=9)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Age- and sex-matched to study group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4" name="Rectangle 5"/>
            <p:cNvSpPr/>
            <p:nvPr/>
          </p:nvSpPr>
          <p:spPr>
            <a:xfrm>
              <a:off x="5350680" y="4249440"/>
              <a:ext cx="2677680" cy="5504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Drop-out 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Schizophrenia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lvl="1" marL="457200" indent="-274680"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Not complete the assessments (n=1)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5" name="Rectangle 6"/>
            <p:cNvSpPr/>
            <p:nvPr/>
          </p:nvSpPr>
          <p:spPr>
            <a:xfrm>
              <a:off x="2100600" y="3395880"/>
              <a:ext cx="4229640" cy="674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Allocated to study 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lvl="1" marL="182520" indent="-95040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- Brain MRI scans and blood sampling for genotyping VRK2 rs2312147 (Schizophrenia, n=37; HC, n=18) 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lvl="1" marL="182520" indent="-95040"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- Assessments of PANSS and DST in schizophrenia group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6" name="Rectangle 7"/>
            <p:cNvSpPr/>
            <p:nvPr/>
          </p:nvSpPr>
          <p:spPr>
            <a:xfrm>
              <a:off x="2099880" y="5219640"/>
              <a:ext cx="4230000" cy="5922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Analyzed  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Schizophrenia (n=36), HC (n=18) 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- VBM, TBSS, genotyping analysis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7" name="Line 8"/>
            <p:cNvSpPr/>
            <p:nvPr/>
          </p:nvSpPr>
          <p:spPr>
            <a:xfrm>
              <a:off x="3991320" y="1513080"/>
              <a:ext cx="0" cy="430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8" name="Line 9"/>
            <p:cNvSpPr/>
            <p:nvPr/>
          </p:nvSpPr>
          <p:spPr>
            <a:xfrm flipH="1">
              <a:off x="3979440" y="2278800"/>
              <a:ext cx="15480" cy="1109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" name="Line 10"/>
            <p:cNvSpPr/>
            <p:nvPr/>
          </p:nvSpPr>
          <p:spPr>
            <a:xfrm>
              <a:off x="3979800" y="4070880"/>
              <a:ext cx="11160" cy="1131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" name="AutoShape 11"/>
            <p:cNvSpPr/>
            <p:nvPr/>
          </p:nvSpPr>
          <p:spPr>
            <a:xfrm>
              <a:off x="208800" y="3413520"/>
              <a:ext cx="1632960" cy="37764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Allocat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1" name="AutoShape 12"/>
            <p:cNvSpPr/>
            <p:nvPr/>
          </p:nvSpPr>
          <p:spPr>
            <a:xfrm>
              <a:off x="208800" y="5373720"/>
              <a:ext cx="1632960" cy="37764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Analysis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" name="AutoShape 13"/>
            <p:cNvSpPr/>
            <p:nvPr/>
          </p:nvSpPr>
          <p:spPr>
            <a:xfrm>
              <a:off x="3116160" y="1943640"/>
              <a:ext cx="1755000" cy="37764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Enrollment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3" name="Line 14"/>
            <p:cNvSpPr/>
            <p:nvPr/>
          </p:nvSpPr>
          <p:spPr>
            <a:xfrm>
              <a:off x="4871520" y="2097720"/>
              <a:ext cx="479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4" name="Line 15"/>
            <p:cNvSpPr/>
            <p:nvPr/>
          </p:nvSpPr>
          <p:spPr>
            <a:xfrm>
              <a:off x="3991320" y="4485960"/>
              <a:ext cx="1359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" name="Text Box 16"/>
            <p:cNvSpPr/>
            <p:nvPr/>
          </p:nvSpPr>
          <p:spPr>
            <a:xfrm>
              <a:off x="155520" y="6295320"/>
              <a:ext cx="8016840" cy="805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CC/CT/TT, The genotypes of rs2312147; DSM-IV-TR, Diagnostic and Statistical Manual of Mental Disorders, 4th Edition, Text Revision; DST, Digit Symbol Test; HC, healthy control; MRI, magnetic resonance imaging; PANSS, Positive and Negative Syndrome Scale; TBSS, Tract-Based Spatial Statistics; VBM, Voxel Based Morphometry; VRK2, vaccinia-related kinase 2 gene.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6" name="AutoShape 17"/>
            <p:cNvSpPr/>
            <p:nvPr/>
          </p:nvSpPr>
          <p:spPr>
            <a:xfrm>
              <a:off x="200520" y="4402080"/>
              <a:ext cx="1627560" cy="33012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Drop-out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57" name="Rectangle 18"/>
          <p:cNvSpPr/>
          <p:nvPr/>
        </p:nvSpPr>
        <p:spPr>
          <a:xfrm>
            <a:off x="32400" y="-27000"/>
            <a:ext cx="443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Fig. S1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 Flow diagram of participation of subjects in this study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25T11:32:13Z</dcterms:created>
  <dc:creator>Borah</dc:creator>
  <dc:description/>
  <dc:language>en-US</dc:language>
  <cp:lastModifiedBy>B</cp:lastModifiedBy>
  <dcterms:modified xsi:type="dcterms:W3CDTF">2014-06-12T12:01:10Z</dcterms:modified>
  <cp:revision>25</cp:revision>
  <dc:subject/>
  <dc:title>슬라이드 1</dc:title>
</cp:coreProperties>
</file>